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72" r:id="rId2"/>
    <p:sldId id="267" r:id="rId3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9" d="100"/>
          <a:sy n="79" d="100"/>
        </p:scale>
        <p:origin x="2476" y="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FD4B7B5-8EE1-4B0C-9EFC-49ED8BCC7643}" type="datetimeFigureOut">
              <a:rPr lang="zh-CN" altLang="en-US" smtClean="0"/>
              <a:t>2024/4/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E401E6-BA18-405C-BDF4-D3DA1562F1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84413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4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1827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4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87177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4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55014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4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86539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4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21841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4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58257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4/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1170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4/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44060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4/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5230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4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47583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4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78056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4/4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030940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内容占位符 5">
            <a:extLst>
              <a:ext uri="{FF2B5EF4-FFF2-40B4-BE49-F238E27FC236}">
                <a16:creationId xmlns:a16="http://schemas.microsoft.com/office/drawing/2014/main" id="{C64E2B28-F525-1BA5-014A-F04A7382B74C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456172621"/>
              </p:ext>
            </p:extLst>
          </p:nvPr>
        </p:nvGraphicFramePr>
        <p:xfrm>
          <a:off x="533746" y="969000"/>
          <a:ext cx="5790508" cy="4308176"/>
        </p:xfrm>
        <a:graphic>
          <a:graphicData uri="http://schemas.openxmlformats.org/drawingml/2006/table">
            <a:tbl>
              <a:tblPr firstRow="1" firstCol="1" bandRow="1"/>
              <a:tblGrid>
                <a:gridCol w="59496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94966">
                  <a:extLst>
                    <a:ext uri="{9D8B030D-6E8A-4147-A177-3AD203B41FA5}">
                      <a16:colId xmlns:a16="http://schemas.microsoft.com/office/drawing/2014/main" val="478680614"/>
                    </a:ext>
                  </a:extLst>
                </a:gridCol>
                <a:gridCol w="367431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26264">
                  <a:extLst>
                    <a:ext uri="{9D8B030D-6E8A-4147-A177-3AD203B41FA5}">
                      <a16:colId xmlns:a16="http://schemas.microsoft.com/office/drawing/2014/main" val="2257130589"/>
                    </a:ext>
                  </a:extLst>
                </a:gridCol>
              </a:tblGrid>
              <a:tr h="254336">
                <a:tc>
                  <a:txBody>
                    <a:bodyPr/>
                    <a:lstStyle/>
                    <a:p>
                      <a:pPr algn="ctr"/>
                      <a:r>
                        <a:rPr lang="en-US" sz="700" b="1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D</a:t>
                      </a:r>
                      <a:r>
                        <a:rPr lang="en-US" altLang="zh-CN" sz="700" b="1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tabase</a:t>
                      </a:r>
                      <a:endParaRPr lang="zh-CN" sz="700" b="1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8932" marR="28932" marT="0" marB="0" anchor="ctr">
                    <a:lnL>
                      <a:noFill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Update date</a:t>
                      </a:r>
                      <a:endParaRPr lang="zh-CN" sz="700" b="1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8932" marR="28932" marT="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b="1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Full search string</a:t>
                      </a:r>
                      <a:endParaRPr lang="zh-CN" sz="700" b="1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8932" marR="28932" marT="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Items hit</a:t>
                      </a:r>
                      <a:endParaRPr lang="zh-CN" sz="700" b="1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8932" marR="28932" marT="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44018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ubMed</a:t>
                      </a:r>
                      <a:endParaRPr lang="zh-CN" sz="7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8932" marR="28932" marT="0" marB="0" anchor="ctr">
                    <a:lnL>
                      <a:noFill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1-Aug-23</a:t>
                      </a:r>
                      <a:endParaRPr lang="zh-CN" sz="7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8932" marR="28932" marT="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altLang="zh-CN" sz="7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"liver"[All Fields] OR "hepatic"[All Fields] OR "hepatocellular"[All Fields] OR "hepatoma"[All Fields])</a:t>
                      </a:r>
                    </a:p>
                    <a:p>
                      <a:pPr algn="ctr"/>
                      <a:endParaRPr lang="en-US" altLang="zh-CN" sz="7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ND</a:t>
                      </a:r>
                    </a:p>
                    <a:p>
                      <a:pPr algn="ctr"/>
                      <a:endParaRPr lang="en-US" altLang="zh-CN" sz="7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"</a:t>
                      </a:r>
                      <a:r>
                        <a:rPr lang="en-US" altLang="zh-CN" sz="7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eoplasm</a:t>
                      </a:r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"[All Fields] OR "cancer"[All Fields] OR "carcinoma"[All Fields] OR "tumor"[All Fields])</a:t>
                      </a:r>
                    </a:p>
                    <a:p>
                      <a:pPr algn="ctr"/>
                      <a:endParaRPr lang="en-US" altLang="zh-CN" sz="7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ND</a:t>
                      </a:r>
                    </a:p>
                    <a:p>
                      <a:pPr algn="ctr"/>
                      <a:endParaRPr lang="en-US" altLang="zh-CN" sz="7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"dietary pattern"[All Fields] OR "eating pattern"[All Fields] OR "food pattern"[All Fields] OR "diet pattern"[All Fields] OR "diet"[All Fields] OR "dietary"[All Fields]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700" kern="100" dirty="0"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8932" marR="28932" marT="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359</a:t>
                      </a:r>
                    </a:p>
                  </a:txBody>
                  <a:tcPr marL="28932" marR="28932" marT="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234440">
                <a:tc>
                  <a:txBody>
                    <a:bodyPr/>
                    <a:lstStyle/>
                    <a:p>
                      <a:pPr algn="ctr"/>
                      <a:r>
                        <a:rPr lang="en-US" sz="7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EMBASE</a:t>
                      </a:r>
                      <a:endParaRPr lang="zh-CN" sz="7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8932" marR="28932" marT="0" marB="0" anchor="ctr">
                    <a:lnL>
                      <a:noFill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700" kern="100" dirty="0"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1-Aug-23</a:t>
                      </a:r>
                      <a:endParaRPr lang="zh-CN" altLang="zh-CN" sz="700" kern="100" dirty="0"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zh-CN" sz="7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8932" marR="28932" marT="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700" kern="100" dirty="0"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(Liver):</a:t>
                      </a:r>
                      <a:r>
                        <a:rPr lang="en-US" altLang="zh-CN" sz="700" kern="100" dirty="0" err="1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i,ab,kw</a:t>
                      </a:r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OR (Hepatic):</a:t>
                      </a:r>
                      <a:r>
                        <a:rPr lang="en-US" altLang="zh-CN" sz="700" kern="100" dirty="0" err="1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i,ab,kw</a:t>
                      </a:r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OR (Hepatocellular):</a:t>
                      </a:r>
                      <a:r>
                        <a:rPr lang="en-US" altLang="zh-CN" sz="700" kern="100" dirty="0" err="1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i,ab,kw</a:t>
                      </a:r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OR (Hepatoma):</a:t>
                      </a:r>
                      <a:r>
                        <a:rPr lang="en-US" altLang="zh-CN" sz="700" kern="100" dirty="0" err="1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i,ab,kw</a:t>
                      </a:r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700" kern="100" dirty="0"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ND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700" kern="100" dirty="0"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Neoplasm):</a:t>
                      </a:r>
                      <a:r>
                        <a:rPr lang="en-US" altLang="zh-CN" sz="700" kern="100" dirty="0" err="1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i,ab,kw</a:t>
                      </a:r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OR (Cancer):</a:t>
                      </a:r>
                      <a:r>
                        <a:rPr lang="en-US" altLang="zh-CN" sz="700" kern="100" dirty="0" err="1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i,ab,kw</a:t>
                      </a:r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OR (Carcinoma):</a:t>
                      </a:r>
                      <a:r>
                        <a:rPr lang="en-US" altLang="zh-CN" sz="700" kern="100" dirty="0" err="1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i,ab,kw</a:t>
                      </a:r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OR (Tumor):</a:t>
                      </a:r>
                      <a:r>
                        <a:rPr lang="en-US" altLang="zh-CN" sz="700" kern="100" dirty="0" err="1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i,ab,kw</a:t>
                      </a:r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700" kern="100" dirty="0"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ND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700" kern="100" dirty="0"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(dietary pattern):</a:t>
                      </a:r>
                      <a:r>
                        <a:rPr lang="en-US" altLang="zh-CN" sz="700" kern="100" dirty="0" err="1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i,ab,kw</a:t>
                      </a:r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OR (eating pattern):</a:t>
                      </a:r>
                      <a:r>
                        <a:rPr lang="en-US" altLang="zh-CN" sz="700" kern="100" dirty="0" err="1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i,ab,kw</a:t>
                      </a:r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OR (food pattern):</a:t>
                      </a:r>
                      <a:r>
                        <a:rPr lang="en-US" altLang="zh-CN" sz="700" kern="100" dirty="0" err="1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i,ab,kw</a:t>
                      </a:r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OR (diet pattern):</a:t>
                      </a:r>
                      <a:r>
                        <a:rPr lang="en-US" altLang="zh-CN" sz="700" kern="100" dirty="0" err="1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i,ab,kw</a:t>
                      </a:r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OR (diet):</a:t>
                      </a:r>
                      <a:r>
                        <a:rPr lang="en-US" altLang="zh-CN" sz="700" kern="100" dirty="0" err="1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i,ab,kw</a:t>
                      </a:r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OR (dietary):</a:t>
                      </a:r>
                      <a:r>
                        <a:rPr lang="en-US" altLang="zh-CN" sz="700" kern="100" dirty="0" err="1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i,ab,kw</a:t>
                      </a:r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)</a:t>
                      </a:r>
                    </a:p>
                    <a:p>
                      <a:pPr algn="ctr"/>
                      <a:endParaRPr lang="zh-CN" sz="7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8932" marR="28932" marT="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524</a:t>
                      </a:r>
                      <a:endParaRPr lang="zh-CN" sz="7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8932" marR="28932" marT="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2344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ochrane Library</a:t>
                      </a:r>
                      <a:endParaRPr lang="zh-CN" altLang="zh-CN" sz="700" kern="100" dirty="0"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8932" marR="28932" marT="0" marB="0" anchor="ctr">
                    <a:lnL>
                      <a:noFill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700" kern="100" dirty="0"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1-Aug-23</a:t>
                      </a:r>
                      <a:endParaRPr lang="zh-CN" altLang="zh-CN" sz="700" kern="100" dirty="0"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zh-CN" sz="700" kern="100" dirty="0"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8932" marR="28932" marT="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700" kern="100" dirty="0"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(Liver):</a:t>
                      </a:r>
                      <a:r>
                        <a:rPr lang="en-US" altLang="zh-CN" sz="700" kern="100" dirty="0" err="1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i,ab,kw</a:t>
                      </a:r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OR (Hepatic):</a:t>
                      </a:r>
                      <a:r>
                        <a:rPr lang="en-US" altLang="zh-CN" sz="700" kern="100" dirty="0" err="1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i,ab,kw</a:t>
                      </a:r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OR (Hepatocellular):</a:t>
                      </a:r>
                      <a:r>
                        <a:rPr lang="en-US" altLang="zh-CN" sz="700" kern="100" dirty="0" err="1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i,ab,kw</a:t>
                      </a:r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OR (Hepatoma):</a:t>
                      </a:r>
                      <a:r>
                        <a:rPr lang="en-US" altLang="zh-CN" sz="700" kern="100" dirty="0" err="1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i,ab,kw</a:t>
                      </a:r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700" kern="100" dirty="0"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ND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700" kern="100" dirty="0"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Neoplasm):</a:t>
                      </a:r>
                      <a:r>
                        <a:rPr lang="en-US" altLang="zh-CN" sz="700" kern="100" dirty="0" err="1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i,ab,kw</a:t>
                      </a:r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OR (Cancer):</a:t>
                      </a:r>
                      <a:r>
                        <a:rPr lang="en-US" altLang="zh-CN" sz="700" kern="100" dirty="0" err="1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i,ab,kw</a:t>
                      </a:r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OR (Carcinoma):</a:t>
                      </a:r>
                      <a:r>
                        <a:rPr lang="en-US" altLang="zh-CN" sz="700" kern="100" dirty="0" err="1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i,ab,kw</a:t>
                      </a:r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OR (Tumor):</a:t>
                      </a:r>
                      <a:r>
                        <a:rPr lang="en-US" altLang="zh-CN" sz="700" kern="100" dirty="0" err="1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i,ab,kw</a:t>
                      </a:r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700" kern="100" dirty="0"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ND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700" kern="100" dirty="0"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(dietary pattern):</a:t>
                      </a:r>
                      <a:r>
                        <a:rPr lang="en-US" altLang="zh-CN" sz="700" kern="100" dirty="0" err="1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i,ab,kw</a:t>
                      </a:r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OR (eating pattern):</a:t>
                      </a:r>
                      <a:r>
                        <a:rPr lang="en-US" altLang="zh-CN" sz="700" kern="100" dirty="0" err="1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i,ab,kw</a:t>
                      </a:r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OR (food pattern):</a:t>
                      </a:r>
                      <a:r>
                        <a:rPr lang="en-US" altLang="zh-CN" sz="700" kern="100" dirty="0" err="1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i,ab,kw</a:t>
                      </a:r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OR (diet pattern):</a:t>
                      </a:r>
                      <a:r>
                        <a:rPr lang="en-US" altLang="zh-CN" sz="700" kern="100" dirty="0" err="1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i,ab,kw</a:t>
                      </a:r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OR (diet):</a:t>
                      </a:r>
                      <a:r>
                        <a:rPr lang="en-US" altLang="zh-CN" sz="700" kern="100" dirty="0" err="1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i,ab,kw</a:t>
                      </a:r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OR (dietary):</a:t>
                      </a:r>
                      <a:r>
                        <a:rPr lang="en-US" altLang="zh-CN" sz="700" kern="100" dirty="0" err="1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i,ab,kw</a:t>
                      </a:r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)</a:t>
                      </a:r>
                    </a:p>
                    <a:p>
                      <a:pPr algn="ctr"/>
                      <a:endParaRPr lang="zh-CN" sz="7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8932" marR="28932" marT="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36</a:t>
                      </a:r>
                      <a:endParaRPr lang="zh-CN" sz="7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8932" marR="28932" marT="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2" name="Rectangle 2">
            <a:extLst>
              <a:ext uri="{FF2B5EF4-FFF2-40B4-BE49-F238E27FC236}">
                <a16:creationId xmlns:a16="http://schemas.microsoft.com/office/drawing/2014/main" id="{6AF87F2A-9888-83DD-7536-54AB506828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3746" y="726893"/>
            <a:ext cx="2778966" cy="1620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38576" tIns="19289" rIns="38576" bIns="19289" numCol="1" anchor="ctr" anchorCtr="0" compatLnSpc="1">
            <a:spAutoFit/>
          </a:bodyPr>
          <a:lstStyle/>
          <a:p>
            <a:pPr defTabSz="385763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sz="800" b="1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upplementary Table 1. Search terms in each database</a:t>
            </a:r>
          </a:p>
        </p:txBody>
      </p:sp>
    </p:spTree>
    <p:extLst>
      <p:ext uri="{BB962C8B-B14F-4D97-AF65-F5344CB8AC3E}">
        <p14:creationId xmlns:p14="http://schemas.microsoft.com/office/powerpoint/2010/main" val="5823363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36033" y="1578513"/>
            <a:ext cx="1849446" cy="1344785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1152" y="1578512"/>
            <a:ext cx="1849446" cy="1344785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1152" y="5109872"/>
            <a:ext cx="1849446" cy="1344785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1152" y="3343323"/>
            <a:ext cx="1849446" cy="1344785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36034" y="5109872"/>
            <a:ext cx="1849446" cy="1344785"/>
          </a:xfrm>
          <a:prstGeom prst="rect">
            <a:avLst/>
          </a:prstGeom>
        </p:spPr>
      </p:pic>
      <p:sp>
        <p:nvSpPr>
          <p:cNvPr id="15" name="文本框 14"/>
          <p:cNvSpPr txBox="1"/>
          <p:nvPr/>
        </p:nvSpPr>
        <p:spPr>
          <a:xfrm>
            <a:off x="1147504" y="1578512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3315540" y="1576775"/>
            <a:ext cx="25680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1099407" y="3341585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3361599" y="3176161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1114926" y="4941840"/>
            <a:ext cx="2792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图片 20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36033" y="3344192"/>
            <a:ext cx="1849447" cy="1344785"/>
          </a:xfrm>
          <a:prstGeom prst="rect">
            <a:avLst/>
          </a:prstGeom>
        </p:spPr>
      </p:pic>
      <p:sp>
        <p:nvSpPr>
          <p:cNvPr id="22" name="文本框 21"/>
          <p:cNvSpPr txBox="1"/>
          <p:nvPr/>
        </p:nvSpPr>
        <p:spPr>
          <a:xfrm>
            <a:off x="3332348" y="4941840"/>
            <a:ext cx="2712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zh-CN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Rectangle 2">
            <a:extLst>
              <a:ext uri="{FF2B5EF4-FFF2-40B4-BE49-F238E27FC236}">
                <a16:creationId xmlns:a16="http://schemas.microsoft.com/office/drawing/2014/main" id="{F6115807-1196-70A3-E342-1DC45A38D20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91133" y="950868"/>
            <a:ext cx="4258767" cy="4082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38576" tIns="19289" rIns="38576" bIns="19289" numCol="1" anchor="ctr" anchorCtr="0" compatLnSpc="1">
            <a:spAutoFit/>
          </a:bodyPr>
          <a:lstStyle/>
          <a:p>
            <a:pPr defTabSz="385763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sz="800" b="1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upplementary Figure 1. Funnel plots depicting publication bias in studies, using pseudo 95% confidence intervals, categorized by dietary patterns.</a:t>
            </a:r>
          </a:p>
          <a:p>
            <a:pPr defTabSz="385763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sz="800" b="1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(A) HEI, (B) </a:t>
            </a:r>
            <a:r>
              <a:rPr lang="en-US" altLang="zh-CN" sz="800" b="1" dirty="0" err="1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HEI</a:t>
            </a:r>
            <a:r>
              <a:rPr lang="en-US" altLang="zh-CN" sz="800" b="1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, (C) DASH, (D) </a:t>
            </a:r>
            <a:r>
              <a:rPr lang="en-US" altLang="zh-CN" sz="800" b="1" dirty="0" err="1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MED</a:t>
            </a:r>
            <a:r>
              <a:rPr lang="en-US" altLang="zh-CN" sz="800" b="1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, (E) DII, (F) Vegetable-based diet.</a:t>
            </a:r>
          </a:p>
        </p:txBody>
      </p:sp>
      <p:sp>
        <p:nvSpPr>
          <p:cNvPr id="7" name="Rectangle 2">
            <a:extLst>
              <a:ext uri="{FF2B5EF4-FFF2-40B4-BE49-F238E27FC236}">
                <a16:creationId xmlns:a16="http://schemas.microsoft.com/office/drawing/2014/main" id="{BE107D19-4B4F-46CE-9FC2-7E7A42459C5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11152" y="6664758"/>
            <a:ext cx="4200180" cy="90072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38576" tIns="19289" rIns="38576" bIns="19289" numCol="1" anchor="ctr" anchorCtr="0" compatLnSpc="1">
            <a:spAutoFit/>
          </a:bodyPr>
          <a:lstStyle/>
          <a:p>
            <a:pPr defTabSz="385763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sz="8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he Egger’s funnel plot, incorporating pseudo 95% confidence intervals, graphically represents log hazard ratios (HRs) versus their respective standard errors, for studies examining the relationship between adherence to various dietary patterns and liver cancer risk.</a:t>
            </a:r>
          </a:p>
          <a:p>
            <a:pPr defTabSz="385763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sz="8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bbreviations: HEI, Healthy Eating Index; </a:t>
            </a:r>
            <a:r>
              <a:rPr lang="en-US" altLang="zh-CN" sz="800" dirty="0" err="1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HEI</a:t>
            </a:r>
            <a:r>
              <a:rPr lang="en-US" altLang="zh-CN" sz="8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, Alternative Healthy Eating Index; DASH,  Dietary Approaches to Stop Hypertension; </a:t>
            </a:r>
            <a:r>
              <a:rPr lang="en-US" altLang="zh-CN" sz="800" dirty="0" err="1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MED</a:t>
            </a:r>
            <a:r>
              <a:rPr lang="en-US" altLang="zh-CN" sz="8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, Alternate Mediterranean Diet; DII, Dietary Inflammatory Index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WPS">
  <a:themeElements>
    <a:clrScheme name="WPS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4874CB"/>
      </a:accent1>
      <a:accent2>
        <a:srgbClr val="E6724B"/>
      </a:accent2>
      <a:accent3>
        <a:srgbClr val="EFBB1F"/>
      </a:accent3>
      <a:accent4>
        <a:srgbClr val="75BD42"/>
      </a:accent4>
      <a:accent5>
        <a:srgbClr val="30C0B4"/>
      </a:accent5>
      <a:accent6>
        <a:srgbClr val="E05269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WPS" id="{8741FFC2-4D7D-48D1-88A6-21A4E405BEEE}" vid="{BE4B9CD3-767A-4D54-8AE3-5DB2A8AFC4DC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9</TotalTime>
  <Words>530</Words>
  <Application>Microsoft Office PowerPoint</Application>
  <PresentationFormat>全屏显示(4:3)</PresentationFormat>
  <Paragraphs>56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等线</vt:lpstr>
      <vt:lpstr>Arial</vt:lpstr>
      <vt:lpstr>Calibri</vt:lpstr>
      <vt:lpstr>WPS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刘玲</dc:creator>
  <cp:lastModifiedBy>WX SHU</cp:lastModifiedBy>
  <cp:revision>6</cp:revision>
  <dcterms:created xsi:type="dcterms:W3CDTF">2023-12-05T04:52:11Z</dcterms:created>
  <dcterms:modified xsi:type="dcterms:W3CDTF">2024-04-02T10:01:30Z</dcterms:modified>
</cp:coreProperties>
</file>